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845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0627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531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226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4138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4419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6075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7815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9820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3798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596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BB12D-0259-4C12-8AB5-328D3E7056B8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6EC9F-EB69-4F7F-900E-432739333B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0010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5166" y="237757"/>
            <a:ext cx="2813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7688" y="5530944"/>
            <a:ext cx="948192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e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e showing the relationship between 16S rDNA sequences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trived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isolates with references in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 phylogenetic tree was generated from the maximum likelihood method (bootstrap 1000 replicates) using the MEGA X software.</a:t>
            </a:r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87" b="20045"/>
          <a:stretch/>
        </p:blipFill>
        <p:spPr>
          <a:xfrm>
            <a:off x="483705" y="959077"/>
            <a:ext cx="7894320" cy="457186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600090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3</Words>
  <Application>Microsoft Office PowerPoint</Application>
  <PresentationFormat>와이드스크린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6</cp:revision>
  <dcterms:created xsi:type="dcterms:W3CDTF">2021-03-15T08:17:38Z</dcterms:created>
  <dcterms:modified xsi:type="dcterms:W3CDTF">2021-07-21T09:13:31Z</dcterms:modified>
</cp:coreProperties>
</file>